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7F874-4B55-4B70-A0CD-8A11E3FA1F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1DAE3-90C0-4997-9965-CE85B90077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DC3B91-A36B-4828-9E60-3C3C49AC25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DF4EE-5394-4879-94D0-963E59AC33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07674-0DB4-4301-BDF3-72AF21C1C5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E037C7-289D-4A80-8A8E-FE4A5C4988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08A1AF-D306-4E10-9643-16AB7435F3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03123-5D94-41B6-A01D-298B4ECE7C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93C16-90CC-4469-BF8A-D275362629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123EDC-ECE2-4F98-B2DC-6D7252828D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2188A-50CA-4C92-8EBE-BA0692324F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35BE2-974D-4E29-A165-ED8304E445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6E042A-CA92-4F0E-B83F-CCF1FF89453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Legend for Figure</a:t>
            </a:r>
            <a:r>
              <a:rPr b="0" lang="en-US" sz="3200" spc="-1" strike="noStrike">
                <a:solidFill>
                  <a:srgbClr val="000000"/>
                </a:solidFill>
                <a:latin typeface="Calibri"/>
                <a:ea typeface="宋体"/>
              </a:rPr>
              <a:t> </a:t>
            </a: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0" lang="en-US" sz="3200" spc="-1" strike="noStrike">
                <a:solidFill>
                  <a:srgbClr val="000000"/>
                </a:solidFill>
                <a:latin typeface="Calibri"/>
                <a:ea typeface="宋体"/>
              </a:rPr>
              <a:t>2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Figure S2: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Kaplan-Meier curves demonstrate CNAs showing significant association with overall survival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. Gain of chromosome 20q11.21-q13.33 (chr20:29,297,270-62,435,964bp) (A) and a GISTIC peak within (20q13.33, chr20:61,440,621-61,778,204bp) (B) are associated with good overall survival in 239 stage III samples. Deletion of the distal tip of the short arm of chromosome 10 (10p15.3-p14, chr10:0-10,743,764bp) (C) and deletion of 19p13.12 (chr19:14,425,490-15,580,441bp) (D) are associated with poor overall survival in 269 stage II/III samples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3" descr=""/>
          <p:cNvPicPr/>
          <p:nvPr/>
        </p:nvPicPr>
        <p:blipFill>
          <a:blip r:embed="rId1"/>
          <a:srcRect l="33139" t="52648" r="44382" b="15269"/>
          <a:stretch/>
        </p:blipFill>
        <p:spPr>
          <a:xfrm>
            <a:off x="2438280" y="1295280"/>
            <a:ext cx="5123160" cy="3962520"/>
          </a:xfrm>
          <a:prstGeom prst="rect">
            <a:avLst/>
          </a:prstGeom>
          <a:ln w="0">
            <a:noFill/>
          </a:ln>
        </p:spPr>
      </p:pic>
      <p:sp>
        <p:nvSpPr>
          <p:cNvPr id="44" name="TextBox 7"/>
          <p:cNvSpPr/>
          <p:nvPr/>
        </p:nvSpPr>
        <p:spPr>
          <a:xfrm>
            <a:off x="1440" y="6488280"/>
            <a:ext cx="365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7"/>
          <p:cNvSpPr/>
          <p:nvPr/>
        </p:nvSpPr>
        <p:spPr>
          <a:xfrm>
            <a:off x="1440" y="648828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1"/>
          <a:srcRect l="40525" t="30210" r="25605" b="25000"/>
          <a:stretch/>
        </p:blipFill>
        <p:spPr>
          <a:xfrm>
            <a:off x="2362320" y="1371600"/>
            <a:ext cx="4962240" cy="3809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3" descr=""/>
          <p:cNvPicPr/>
          <p:nvPr/>
        </p:nvPicPr>
        <p:blipFill>
          <a:blip r:embed="rId1"/>
          <a:srcRect l="33564" t="21342" r="44805" b="47356"/>
          <a:stretch/>
        </p:blipFill>
        <p:spPr>
          <a:xfrm>
            <a:off x="2340000" y="1371600"/>
            <a:ext cx="5051520" cy="3962520"/>
          </a:xfrm>
          <a:prstGeom prst="rect">
            <a:avLst/>
          </a:prstGeom>
          <a:ln w="0">
            <a:noFill/>
          </a:ln>
        </p:spPr>
      </p:pic>
      <p:sp>
        <p:nvSpPr>
          <p:cNvPr id="48" name="TextBox 7"/>
          <p:cNvSpPr/>
          <p:nvPr/>
        </p:nvSpPr>
        <p:spPr>
          <a:xfrm>
            <a:off x="2160" y="6488280"/>
            <a:ext cx="35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3" descr=""/>
          <p:cNvPicPr/>
          <p:nvPr/>
        </p:nvPicPr>
        <p:blipFill>
          <a:blip r:embed="rId1"/>
          <a:srcRect l="59438" t="21342" r="18932" b="47356"/>
          <a:stretch/>
        </p:blipFill>
        <p:spPr>
          <a:xfrm>
            <a:off x="2340000" y="1371600"/>
            <a:ext cx="5051520" cy="3962520"/>
          </a:xfrm>
          <a:prstGeom prst="rect">
            <a:avLst/>
          </a:prstGeom>
          <a:ln w="0">
            <a:noFill/>
          </a:ln>
        </p:spPr>
      </p:pic>
      <p:sp>
        <p:nvSpPr>
          <p:cNvPr id="50" name="TextBox 7"/>
          <p:cNvSpPr/>
          <p:nvPr/>
        </p:nvSpPr>
        <p:spPr>
          <a:xfrm>
            <a:off x="2160" y="648828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0T05:20:07Z</dcterms:created>
  <dc:creator>xiet02</dc:creator>
  <dc:description/>
  <dc:language>en-US</dc:language>
  <cp:lastModifiedBy>Tao Xie</cp:lastModifiedBy>
  <dcterms:modified xsi:type="dcterms:W3CDTF">2012-07-09T17:16:39Z</dcterms:modified>
  <cp:revision>27</cp:revision>
  <dc:subject/>
  <dc:title>Slide 1</dc:title>
</cp:coreProperties>
</file>